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8" r:id="rId2"/>
    <p:sldId id="296" r:id="rId3"/>
    <p:sldId id="297" r:id="rId4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660"/>
  </p:normalViewPr>
  <p:slideViewPr>
    <p:cSldViewPr snapToGrid="0">
      <p:cViewPr>
        <p:scale>
          <a:sx n="60" d="100"/>
          <a:sy n="60" d="100"/>
        </p:scale>
        <p:origin x="1074" y="8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321F67D5-B1E3-88E0-9ABE-FAA98F9A71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AA763863-2666-7875-4FC1-8874C31BB7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6DAC6596-0CC7-1326-9DFB-57350F9CF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BDF4-80A8-411A-8543-1E9478694D9F}" type="datetimeFigureOut">
              <a:rPr lang="nb-NO" smtClean="0"/>
              <a:t>27.04.2026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326B1538-9DA1-C935-A8D2-1A905A2C3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BABBA82D-2509-9CFA-D9CB-16EA10671D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54F15-A476-4567-906A-08315BB379F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29972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50583860-A9B0-0927-23ED-6144C4D315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DF6BF7FA-A146-E618-A44F-940D3D3ADA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DBEC8257-8724-FD9C-8BC0-3C53AD16D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BDF4-80A8-411A-8543-1E9478694D9F}" type="datetimeFigureOut">
              <a:rPr lang="nb-NO" smtClean="0"/>
              <a:t>27.04.2026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4FD883AF-97AB-E0B0-3464-34C5DB203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3D09EFFB-46AE-4653-2D3E-FA8F60973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54F15-A476-4567-906A-08315BB379F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08145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81348E3B-7EAA-F4FE-1C4C-8D18811667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F8375236-5D00-B924-4D66-724CB2EB5C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D69037A2-1C14-E88A-2F0D-15574578C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BDF4-80A8-411A-8543-1E9478694D9F}" type="datetimeFigureOut">
              <a:rPr lang="nb-NO" smtClean="0"/>
              <a:t>27.04.2026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F1CDEC7E-F708-BFCF-E0DE-D7CFE57272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4B43ABF0-2348-2DE7-AC64-3F259526C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54F15-A476-4567-906A-08315BB379F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8160322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tel">
            <a:extLst>
              <a:ext uri="{FF2B5EF4-FFF2-40B4-BE49-F238E27FC236}">
                <a16:creationId xmlns:a16="http://schemas.microsoft.com/office/drawing/2014/main" id="{4DC0FE1D-5251-F8FE-CFE2-DA04D8E88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5949" y="365126"/>
            <a:ext cx="11034387" cy="1001294"/>
          </a:xfrm>
        </p:spPr>
        <p:txBody>
          <a:bodyPr/>
          <a:lstStyle/>
          <a:p>
            <a:r>
              <a:rPr lang="nb-NO"/>
              <a:t>Klikk for å redigere tittelstil</a:t>
            </a:r>
            <a:endParaRPr lang="nb-NO" dirty="0"/>
          </a:p>
        </p:txBody>
      </p:sp>
      <p:sp>
        <p:nvSpPr>
          <p:cNvPr id="3" name="Plassholder for innhold 1" descr="Klikk for å redigere tekststiler i malen">
            <a:extLst>
              <a:ext uri="{FF2B5EF4-FFF2-40B4-BE49-F238E27FC236}">
                <a16:creationId xmlns:a16="http://schemas.microsoft.com/office/drawing/2014/main" id="{80FB60E4-9D32-0846-B8BB-D8ACEE6ED1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535949" y="1606062"/>
            <a:ext cx="5220000" cy="4247768"/>
          </a:xfrm>
        </p:spPr>
        <p:txBody>
          <a:bodyPr>
            <a:normAutofit/>
          </a:bodyPr>
          <a:lstStyle>
            <a:lvl1pPr>
              <a:defRPr sz="2400" b="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2" descr="Klikk for å redigere tekststiler i malen">
            <a:extLst>
              <a:ext uri="{FF2B5EF4-FFF2-40B4-BE49-F238E27FC236}">
                <a16:creationId xmlns:a16="http://schemas.microsoft.com/office/drawing/2014/main" id="{4A7ACAD7-72B5-0D48-840B-452B3A1E13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350336" y="1606062"/>
            <a:ext cx="5220000" cy="4247768"/>
          </a:xfrm>
        </p:spPr>
        <p:txBody>
          <a:bodyPr>
            <a:normAutofit/>
          </a:bodyPr>
          <a:lstStyle>
            <a:lvl1pPr>
              <a:defRPr sz="2400" b="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10" name="Kildehenvisning">
            <a:extLst>
              <a:ext uri="{FF2B5EF4-FFF2-40B4-BE49-F238E27FC236}">
                <a16:creationId xmlns:a16="http://schemas.microsoft.com/office/drawing/2014/main" id="{5292FFB7-C40D-654F-99EA-194D09B8CFFA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7459663" y="6370638"/>
            <a:ext cx="3208337" cy="365125"/>
          </a:xfrm>
        </p:spPr>
        <p:txBody>
          <a:bodyPr>
            <a:normAutofit/>
          </a:bodyPr>
          <a:lstStyle>
            <a:lvl1pPr algn="r">
              <a:buNone/>
              <a:defRPr lang="nb-NO" sz="1100" b="0" i="0" smtClean="0">
                <a:effectLst/>
                <a:latin typeface="Helvetica" pitchFamily="2" charset="0"/>
              </a:defRPr>
            </a:lvl1pPr>
            <a:lvl2pPr>
              <a:defRPr sz="900"/>
            </a:lvl2pPr>
            <a:lvl3pPr>
              <a:defRPr sz="900"/>
            </a:lvl3pPr>
            <a:lvl4pPr>
              <a:defRPr sz="900"/>
            </a:lvl4pPr>
            <a:lvl5pPr>
              <a:defRPr sz="900"/>
            </a:lvl5pPr>
          </a:lstStyle>
          <a:p>
            <a:pPr lvl="0"/>
            <a:r>
              <a:rPr lang="nb-NO" b="0" i="0" dirty="0">
                <a:solidFill>
                  <a:srgbClr val="202124"/>
                </a:solidFill>
                <a:effectLst/>
                <a:latin typeface="arial" panose="020B0604020202020204" pitchFamily="34" charset="0"/>
              </a:rPr>
              <a:t>© </a:t>
            </a:r>
            <a:r>
              <a:rPr lang="nb-NO" dirty="0"/>
              <a:t>Copyright / kildehenvisning</a:t>
            </a:r>
          </a:p>
        </p:txBody>
      </p:sp>
      <p:sp>
        <p:nvSpPr>
          <p:cNvPr id="5" name="Sidetall">
            <a:extLst>
              <a:ext uri="{FF2B5EF4-FFF2-40B4-BE49-F238E27FC236}">
                <a16:creationId xmlns:a16="http://schemas.microsoft.com/office/drawing/2014/main" id="{E87323BC-D981-E141-A5E2-F609B886ACD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34E9FF-35ED-4746-A218-B58892FE7A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77467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F1FBA291-D1CD-F960-79F7-3A11F784C8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011E4F00-B62C-6063-FEAA-92A9D00912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46CD72B6-C160-AA43-3CD6-D7FF044DF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BDF4-80A8-411A-8543-1E9478694D9F}" type="datetimeFigureOut">
              <a:rPr lang="nb-NO" smtClean="0"/>
              <a:t>27.04.2026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F0CA560C-A1FF-FA80-ED64-257F48BA4C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0091261D-A8E6-7FD8-0D48-F486B0255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54F15-A476-4567-906A-08315BB379F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06863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366FA493-1B0A-3319-3DD1-E92DD4CEA7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5C4215FF-BD5C-7431-E193-0F249DE6E3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2C4AD656-2567-76F0-622A-83F19F333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BDF4-80A8-411A-8543-1E9478694D9F}" type="datetimeFigureOut">
              <a:rPr lang="nb-NO" smtClean="0"/>
              <a:t>27.04.2026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056C2350-6119-C124-AA2E-E524A5386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6284796D-BF9B-4139-80C6-2320CB5906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54F15-A476-4567-906A-08315BB379F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658909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840E2B9B-C780-E229-E400-947575B299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43C2C426-9C6A-7D78-F448-B6131C5DA8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3BE0B61D-AFF0-2C7C-A9D7-ADEDD0C306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2318371C-FD30-B15D-AF7B-19A6946FFE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BDF4-80A8-411A-8543-1E9478694D9F}" type="datetimeFigureOut">
              <a:rPr lang="nb-NO" smtClean="0"/>
              <a:t>27.04.2026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DAAE0EC8-EA96-CE24-EC10-0B8B3037F0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87216057-1E0C-C504-4494-896E046F24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54F15-A476-4567-906A-08315BB379F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44611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A29C7203-3C16-379D-51BA-368BEB223E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6C889693-47A0-5262-7E1F-97BBD02846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B489A4C9-6308-E3E9-A0EF-6FAB668597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B2D56743-80A0-219F-73CB-451054A88E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F5B77D27-F147-31DB-A4CD-BEB3B7D980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1FD54578-8622-3055-B658-3F3A042F5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BDF4-80A8-411A-8543-1E9478694D9F}" type="datetimeFigureOut">
              <a:rPr lang="nb-NO" smtClean="0"/>
              <a:t>27.04.2026</a:t>
            </a:fld>
            <a:endParaRPr lang="nb-NO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B3445BC3-2AF0-C8E7-3F78-A8CA6A827B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0A8033AB-BACE-1502-89AD-66FF827E1E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54F15-A476-4567-906A-08315BB379F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692697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A0EDAE87-08E3-0CDE-5767-0743857E71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02C3405B-17D8-D1C5-690D-2696B50BD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BDF4-80A8-411A-8543-1E9478694D9F}" type="datetimeFigureOut">
              <a:rPr lang="nb-NO" smtClean="0"/>
              <a:t>27.04.2026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CCAA7C49-2286-BF02-F342-E1D33A3AAF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4EC4764D-3BEF-DACA-546A-900C305FA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54F15-A476-4567-906A-08315BB379F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330663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92F18131-4BC6-101D-536D-4363C3822B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BDF4-80A8-411A-8543-1E9478694D9F}" type="datetimeFigureOut">
              <a:rPr lang="nb-NO" smtClean="0"/>
              <a:t>27.04.2026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F436B0DA-11F3-FB3A-3653-C5C1B3FF9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D02062C7-C6C4-B616-5A6C-132898316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54F15-A476-4567-906A-08315BB379F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27563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CD92857D-25F5-A6FA-A3E6-4E52C40D6E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CFAF580F-7399-D739-AB03-4724C69013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D4AE2BFE-A41C-B0CB-9D48-14E15D601E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5BB8C65C-3E7B-A866-87BC-3743C566AF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BDF4-80A8-411A-8543-1E9478694D9F}" type="datetimeFigureOut">
              <a:rPr lang="nb-NO" smtClean="0"/>
              <a:t>27.04.2026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979DBDB9-6D5B-AB73-47BC-6DA618593F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4A69EB53-6983-F52A-E8F9-CD7985E328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54F15-A476-4567-906A-08315BB379F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1255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5E85A7C4-FD48-CC24-90FD-82B64ED5ED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C1B9410E-21F7-0CA2-7794-7F73294ADA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F2EF5CCF-1F39-CD23-5620-50A1390BC3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6C74016A-C7CA-9370-8048-B0BFDB066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BDF4-80A8-411A-8543-1E9478694D9F}" type="datetimeFigureOut">
              <a:rPr lang="nb-NO" smtClean="0"/>
              <a:t>27.04.2026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E73568C1-B0EE-8C15-938E-FAC1EEE10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5DD04120-0045-4396-BE4B-B8F1DF033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54F15-A476-4567-906A-08315BB379F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77003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1D676A5F-8184-F387-F3A3-7A0C9099DC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D6838C3C-705B-29CA-91BD-D00646F7F1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D633CB38-5222-D6D7-143B-6461A5BCD8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107BDF4-80A8-411A-8543-1E9478694D9F}" type="datetimeFigureOut">
              <a:rPr lang="nb-NO" smtClean="0"/>
              <a:t>27.04.2026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211FC43E-8591-0E48-1197-9FEE8AE802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0C2664B8-243E-1C78-0A55-5ACEC509E8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E654F15-A476-4567-906A-08315BB379F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6911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DCE332E-8AA5-F1F3-714A-979393EDCCE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25E58C-6EC1-E316-8429-D1508F5C42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nb-NO" sz="3200" b="1" dirty="0" err="1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trition</a:t>
            </a:r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3200" b="1" dirty="0" err="1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w</a:t>
            </a:r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-</a:t>
            </a:r>
            <a:r>
              <a:rPr lang="nb-NO" sz="3200" b="1" dirty="0" err="1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arning</a:t>
            </a:r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3200" b="1" dirty="0" err="1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ource</a:t>
            </a:r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screenshots)</a:t>
            </a:r>
            <a:endParaRPr lang="nb-NO" sz="3200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3714237-3122-B0A9-3FAE-A2CEED242734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D8C534-4965-9C0C-AF22-48C20AC65265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34E9FF-35ED-4746-A218-B58892FE7A5D}" type="slidenum">
              <a:rPr kumimoji="0" lang="nb-NO" sz="1200" b="0" i="0" u="none" strike="noStrike" kern="1200" cap="none" spc="0" normalizeH="0" baseline="0" noProof="0" smtClean="0">
                <a:ln>
                  <a:noFill/>
                </a:ln>
                <a:solidFill>
                  <a:srgbClr val="1B2343">
                    <a:tint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nb-NO" sz="1200" b="0" i="0" u="none" strike="noStrike" kern="1200" cap="none" spc="0" normalizeH="0" baseline="0" noProof="0">
              <a:ln>
                <a:noFill/>
              </a:ln>
              <a:solidFill>
                <a:srgbClr val="1B2343">
                  <a:tint val="75000"/>
                </a:srgb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8" name="Plassholder for innhold 7">
            <a:extLst>
              <a:ext uri="{FF2B5EF4-FFF2-40B4-BE49-F238E27FC236}">
                <a16:creationId xmlns:a16="http://schemas.microsoft.com/office/drawing/2014/main" id="{9B289545-0D8F-4609-951B-506DC2EEC95A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5941415" y="2011150"/>
            <a:ext cx="5628286" cy="3437362"/>
          </a:xfrm>
          <a:prstGeom prst="rect">
            <a:avLst/>
          </a:prstGeom>
        </p:spPr>
      </p:pic>
      <p:sp>
        <p:nvSpPr>
          <p:cNvPr id="9" name="TekstSylinder 8">
            <a:extLst>
              <a:ext uri="{FF2B5EF4-FFF2-40B4-BE49-F238E27FC236}">
                <a16:creationId xmlns:a16="http://schemas.microsoft.com/office/drawing/2014/main" id="{677808A0-DB82-F162-64E0-D7947801B2A1}"/>
              </a:ext>
            </a:extLst>
          </p:cNvPr>
          <p:cNvSpPr txBox="1"/>
          <p:nvPr/>
        </p:nvSpPr>
        <p:spPr>
          <a:xfrm>
            <a:off x="535949" y="5448511"/>
            <a:ext cx="5332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ur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1. First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ag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f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e-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earning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sourc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</p:txBody>
      </p:sp>
      <p:sp>
        <p:nvSpPr>
          <p:cNvPr id="10" name="TekstSylinder 9">
            <a:extLst>
              <a:ext uri="{FF2B5EF4-FFF2-40B4-BE49-F238E27FC236}">
                <a16:creationId xmlns:a16="http://schemas.microsoft.com/office/drawing/2014/main" id="{5E8BAD63-B190-2689-E909-F974AC2CB4A6}"/>
              </a:ext>
            </a:extLst>
          </p:cNvPr>
          <p:cNvSpPr txBox="1"/>
          <p:nvPr/>
        </p:nvSpPr>
        <p:spPr>
          <a:xfrm>
            <a:off x="5941415" y="5448135"/>
            <a:ext cx="53323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ur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2.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arent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ction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f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e-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earning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sourc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(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vailabl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in Norwegian, English and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abic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)</a:t>
            </a:r>
          </a:p>
        </p:txBody>
      </p:sp>
      <p:pic>
        <p:nvPicPr>
          <p:cNvPr id="20" name="Plassholder for innhold 19">
            <a:extLst>
              <a:ext uri="{FF2B5EF4-FFF2-40B4-BE49-F238E27FC236}">
                <a16:creationId xmlns:a16="http://schemas.microsoft.com/office/drawing/2014/main" id="{0AA8C041-A9EB-51F2-6294-6EB0D5BAF35D}"/>
              </a:ext>
            </a:extLst>
          </p:cNvPr>
          <p:cNvPicPr>
            <a:picLocks noGrp="1" noChangeAspect="1"/>
          </p:cNvPicPr>
          <p:nvPr>
            <p:ph sz="half"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575" y="1984545"/>
            <a:ext cx="5219700" cy="34905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2716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85CDB052-EC70-F0DE-81E0-5C60AF04EA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nb-NO" sz="3200" b="1" dirty="0" err="1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trition</a:t>
            </a:r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3200" b="1" dirty="0" err="1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w</a:t>
            </a:r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-</a:t>
            </a:r>
            <a:r>
              <a:rPr lang="nb-NO" sz="3200" b="1" dirty="0" err="1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arning</a:t>
            </a:r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3200" b="1" dirty="0" err="1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ource</a:t>
            </a:r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screenshots)</a:t>
            </a:r>
            <a:endParaRPr lang="nb-NO" sz="3200" dirty="0"/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F2D53218-998A-F4A7-76EE-2D63ED261CB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1E07C3BE-4C95-371E-C903-14887C64AC47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34E9FF-35ED-4746-A218-B58892FE7A5D}" type="slidenum">
              <a:rPr kumimoji="0" lang="nb-NO" sz="1200" b="0" i="0" u="none" strike="noStrike" kern="1200" cap="none" spc="0" normalizeH="0" baseline="0" noProof="0" smtClean="0">
                <a:ln>
                  <a:noFill/>
                </a:ln>
                <a:solidFill>
                  <a:srgbClr val="1B2343">
                    <a:tint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nb-NO" sz="1200" b="0" i="0" u="none" strike="noStrike" kern="1200" cap="none" spc="0" normalizeH="0" baseline="0" noProof="0">
              <a:ln>
                <a:noFill/>
              </a:ln>
              <a:solidFill>
                <a:srgbClr val="1B2343">
                  <a:tint val="75000"/>
                </a:srgb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7" name="Plassholder for innhold 6">
            <a:extLst>
              <a:ext uri="{FF2B5EF4-FFF2-40B4-BE49-F238E27FC236}">
                <a16:creationId xmlns:a16="http://schemas.microsoft.com/office/drawing/2014/main" id="{08DC7F53-9529-79DA-B6E9-B1438F7B990B}"/>
              </a:ext>
            </a:extLst>
          </p:cNvPr>
          <p:cNvPicPr>
            <a:picLocks noGrp="1" noChangeAspect="1"/>
          </p:cNvPicPr>
          <p:nvPr>
            <p:ph sz="half" idx="1"/>
          </p:nvPr>
        </p:nvPicPr>
        <p:blipFill>
          <a:blip r:embed="rId2"/>
          <a:stretch>
            <a:fillRect/>
          </a:stretch>
        </p:blipFill>
        <p:spPr>
          <a:xfrm>
            <a:off x="536575" y="1630533"/>
            <a:ext cx="5219700" cy="4198596"/>
          </a:xfrm>
          <a:prstGeom prst="rect">
            <a:avLst/>
          </a:prstGeom>
        </p:spPr>
      </p:pic>
      <p:pic>
        <p:nvPicPr>
          <p:cNvPr id="8" name="Plassholder for innhold 7">
            <a:extLst>
              <a:ext uri="{FF2B5EF4-FFF2-40B4-BE49-F238E27FC236}">
                <a16:creationId xmlns:a16="http://schemas.microsoft.com/office/drawing/2014/main" id="{DFC6D30B-8174-1EA7-5118-6E0A4AB37C60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6350000" y="1632514"/>
            <a:ext cx="5219700" cy="4194634"/>
          </a:xfrm>
          <a:prstGeom prst="rect">
            <a:avLst/>
          </a:prstGeom>
        </p:spPr>
      </p:pic>
      <p:sp>
        <p:nvSpPr>
          <p:cNvPr id="9" name="TekstSylinder 8">
            <a:extLst>
              <a:ext uri="{FF2B5EF4-FFF2-40B4-BE49-F238E27FC236}">
                <a16:creationId xmlns:a16="http://schemas.microsoft.com/office/drawing/2014/main" id="{88BA3072-AC68-D29E-B1CE-BE7A916E7EB4}"/>
              </a:ext>
            </a:extLst>
          </p:cNvPr>
          <p:cNvSpPr txBox="1"/>
          <p:nvPr/>
        </p:nvSpPr>
        <p:spPr>
          <a:xfrm>
            <a:off x="480229" y="5778275"/>
            <a:ext cx="5332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ur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3. Pregnant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ction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f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e-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earning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source</a:t>
            </a:r>
            <a:endParaRPr kumimoji="0" lang="nb-NO" sz="1200" b="0" i="0" u="none" strike="noStrike" kern="1200" cap="none" spc="0" normalizeH="0" baseline="0" noProof="0" dirty="0">
              <a:ln>
                <a:noFill/>
              </a:ln>
              <a:solidFill>
                <a:srgbClr val="1B2343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TekstSylinder 9">
            <a:extLst>
              <a:ext uri="{FF2B5EF4-FFF2-40B4-BE49-F238E27FC236}">
                <a16:creationId xmlns:a16="http://schemas.microsoft.com/office/drawing/2014/main" id="{011AC2B2-7376-519D-22E2-6BC70BDED2C1}"/>
              </a:ext>
            </a:extLst>
          </p:cNvPr>
          <p:cNvSpPr txBox="1"/>
          <p:nvPr/>
        </p:nvSpPr>
        <p:spPr>
          <a:xfrm>
            <a:off x="6293654" y="5792175"/>
            <a:ext cx="5332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ur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4.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ewborn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ction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f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e-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earning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source</a:t>
            </a:r>
            <a:endParaRPr kumimoji="0" lang="nb-NO" sz="1200" b="0" i="0" u="none" strike="noStrike" kern="1200" cap="none" spc="0" normalizeH="0" baseline="0" noProof="0" dirty="0">
              <a:ln>
                <a:noFill/>
              </a:ln>
              <a:solidFill>
                <a:srgbClr val="1B2343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634081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7210D348-E802-A221-431E-3F8CDC173F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nb-NO" sz="3200" b="1" dirty="0" err="1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trition</a:t>
            </a:r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3200" b="1" dirty="0" err="1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w</a:t>
            </a:r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-</a:t>
            </a:r>
            <a:r>
              <a:rPr lang="nb-NO" sz="3200" b="1" dirty="0" err="1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arning</a:t>
            </a:r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3200" b="1" dirty="0" err="1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ource</a:t>
            </a:r>
            <a:r>
              <a:rPr lang="nb-NO" sz="3200" b="1" dirty="0">
                <a:solidFill>
                  <a:srgbClr val="C810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screenshots)</a:t>
            </a:r>
            <a:endParaRPr lang="nb-NO" sz="3200" dirty="0"/>
          </a:p>
        </p:txBody>
      </p:sp>
      <p:pic>
        <p:nvPicPr>
          <p:cNvPr id="14" name="Plassholder for innhold 13">
            <a:extLst>
              <a:ext uri="{FF2B5EF4-FFF2-40B4-BE49-F238E27FC236}">
                <a16:creationId xmlns:a16="http://schemas.microsoft.com/office/drawing/2014/main" id="{0367923E-77BC-0913-DEC4-4DDF650A0D5C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165663" y="1841715"/>
            <a:ext cx="5941102" cy="3341869"/>
          </a:xfrm>
          <a:prstGeom prst="rect">
            <a:avLst/>
          </a:prstGeom>
        </p:spPr>
      </p:pic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34C50E03-A2BF-623C-C7C9-71C273AFD188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09DAFAB9-7B8E-B9D0-D2AB-CB55E213F847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34E9FF-35ED-4746-A218-B58892FE7A5D}" type="slidenum">
              <a:rPr kumimoji="0" lang="nb-NO" sz="1200" b="0" i="0" u="none" strike="noStrike" kern="1200" cap="none" spc="0" normalizeH="0" baseline="0" noProof="0" smtClean="0">
                <a:ln>
                  <a:noFill/>
                </a:ln>
                <a:solidFill>
                  <a:srgbClr val="1B2343">
                    <a:tint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nb-NO" sz="1200" b="0" i="0" u="none" strike="noStrike" kern="1200" cap="none" spc="0" normalizeH="0" baseline="0" noProof="0">
              <a:ln>
                <a:noFill/>
              </a:ln>
              <a:solidFill>
                <a:srgbClr val="1B2343">
                  <a:tint val="75000"/>
                </a:srgb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12" name="Plassholder for innhold 11">
            <a:extLst>
              <a:ext uri="{FF2B5EF4-FFF2-40B4-BE49-F238E27FC236}">
                <a16:creationId xmlns:a16="http://schemas.microsoft.com/office/drawing/2014/main" id="{A3F632F6-E3A8-7B83-61EF-71D69F325908}"/>
              </a:ext>
            </a:extLst>
          </p:cNvPr>
          <p:cNvPicPr>
            <a:picLocks noGrp="1" noChangeAspect="1"/>
          </p:cNvPicPr>
          <p:nvPr>
            <p:ph sz="half" idx="1"/>
          </p:nvPr>
        </p:nvPicPr>
        <p:blipFill>
          <a:blip r:embed="rId3"/>
          <a:stretch>
            <a:fillRect/>
          </a:stretch>
        </p:blipFill>
        <p:spPr>
          <a:xfrm>
            <a:off x="396616" y="1882536"/>
            <a:ext cx="5672794" cy="3301048"/>
          </a:xfrm>
          <a:prstGeom prst="rect">
            <a:avLst/>
          </a:prstGeom>
        </p:spPr>
      </p:pic>
      <p:sp>
        <p:nvSpPr>
          <p:cNvPr id="15" name="TekstSylinder 14">
            <a:extLst>
              <a:ext uri="{FF2B5EF4-FFF2-40B4-BE49-F238E27FC236}">
                <a16:creationId xmlns:a16="http://schemas.microsoft.com/office/drawing/2014/main" id="{E4BEAB3B-E136-3216-AFC2-8B12B36905F5}"/>
              </a:ext>
            </a:extLst>
          </p:cNvPr>
          <p:cNvSpPr txBox="1"/>
          <p:nvPr/>
        </p:nvSpPr>
        <p:spPr>
          <a:xfrm>
            <a:off x="480229" y="5248526"/>
            <a:ext cx="5332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ur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5.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cip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ction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f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e-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earning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source</a:t>
            </a:r>
            <a:endParaRPr kumimoji="0" lang="nb-NO" sz="1200" b="0" i="0" u="none" strike="noStrike" kern="1200" cap="none" spc="0" normalizeH="0" baseline="0" noProof="0" dirty="0">
              <a:ln>
                <a:noFill/>
              </a:ln>
              <a:solidFill>
                <a:srgbClr val="1B2343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6" name="TekstSylinder 15">
            <a:extLst>
              <a:ext uri="{FF2B5EF4-FFF2-40B4-BE49-F238E27FC236}">
                <a16:creationId xmlns:a16="http://schemas.microsoft.com/office/drawing/2014/main" id="{C0540FBE-21BB-2EF5-93CE-1F51EED58850}"/>
              </a:ext>
            </a:extLst>
          </p:cNvPr>
          <p:cNvSpPr txBox="1"/>
          <p:nvPr/>
        </p:nvSpPr>
        <p:spPr>
          <a:xfrm>
            <a:off x="6832306" y="5197872"/>
            <a:ext cx="53323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ur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6.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xampl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f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email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ewsletters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sent to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arents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ith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age-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ppropriat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ntent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from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e-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earning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nb-NO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souce</a:t>
            </a:r>
            <a:r>
              <a:rPr kumimoji="0" lang="nb-NO" sz="1200" b="0" i="0" u="none" strike="noStrike" kern="1200" cap="none" spc="0" normalizeH="0" baseline="0" noProof="0" dirty="0">
                <a:ln>
                  <a:noFill/>
                </a:ln>
                <a:solidFill>
                  <a:srgbClr val="1B2343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(in Norwegian) </a:t>
            </a:r>
          </a:p>
        </p:txBody>
      </p:sp>
    </p:spTree>
    <p:extLst>
      <p:ext uri="{BB962C8B-B14F-4D97-AF65-F5344CB8AC3E}">
        <p14:creationId xmlns:p14="http://schemas.microsoft.com/office/powerpoint/2010/main" val="420759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2</Words>
  <Application>Microsoft Office PowerPoint</Application>
  <PresentationFormat>Widescreen</PresentationFormat>
  <Paragraphs>12</Paragraphs>
  <Slides>3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6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3</vt:i4>
      </vt:variant>
    </vt:vector>
  </HeadingPairs>
  <TitlesOfParts>
    <vt:vector size="10" baseType="lpstr">
      <vt:lpstr>Aptos</vt:lpstr>
      <vt:lpstr>Aptos Display</vt:lpstr>
      <vt:lpstr>Arial</vt:lpstr>
      <vt:lpstr>Arial</vt:lpstr>
      <vt:lpstr>Calibri</vt:lpstr>
      <vt:lpstr>Helvetica</vt:lpstr>
      <vt:lpstr>Office-tema</vt:lpstr>
      <vt:lpstr>The Nutrition Now e-learning resource (screenshots)</vt:lpstr>
      <vt:lpstr>The Nutrition Now e-learning resource (screenshots)</vt:lpstr>
      <vt:lpstr>The Nutrition Now e-learning resource (screenshots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talie Garzon Osorio</dc:creator>
  <cp:lastModifiedBy>Natalie Garzon Osorio</cp:lastModifiedBy>
  <cp:revision>1</cp:revision>
  <dcterms:created xsi:type="dcterms:W3CDTF">2026-04-27T20:15:49Z</dcterms:created>
  <dcterms:modified xsi:type="dcterms:W3CDTF">2026-04-27T20:20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95cf23d-70b0-4a80-9221-1d774ac27fb2_Enabled">
    <vt:lpwstr>true</vt:lpwstr>
  </property>
  <property fmtid="{D5CDD505-2E9C-101B-9397-08002B2CF9AE}" pid="3" name="MSIP_Label_695cf23d-70b0-4a80-9221-1d774ac27fb2_SetDate">
    <vt:lpwstr>2026-04-27T20:19:54Z</vt:lpwstr>
  </property>
  <property fmtid="{D5CDD505-2E9C-101B-9397-08002B2CF9AE}" pid="4" name="MSIP_Label_695cf23d-70b0-4a80-9221-1d774ac27fb2_Method">
    <vt:lpwstr>Standard</vt:lpwstr>
  </property>
  <property fmtid="{D5CDD505-2E9C-101B-9397-08002B2CF9AE}" pid="5" name="MSIP_Label_695cf23d-70b0-4a80-9221-1d774ac27fb2_Name">
    <vt:lpwstr>Document internal</vt:lpwstr>
  </property>
  <property fmtid="{D5CDD505-2E9C-101B-9397-08002B2CF9AE}" pid="6" name="MSIP_Label_695cf23d-70b0-4a80-9221-1d774ac27fb2_SiteId">
    <vt:lpwstr>8482881e-3699-4b3f-b135-cf4800bc1efb</vt:lpwstr>
  </property>
  <property fmtid="{D5CDD505-2E9C-101B-9397-08002B2CF9AE}" pid="7" name="MSIP_Label_695cf23d-70b0-4a80-9221-1d774ac27fb2_ActionId">
    <vt:lpwstr>9465bed7-c44f-49c8-8587-b4c721fc10d7</vt:lpwstr>
  </property>
  <property fmtid="{D5CDD505-2E9C-101B-9397-08002B2CF9AE}" pid="8" name="MSIP_Label_695cf23d-70b0-4a80-9221-1d774ac27fb2_ContentBits">
    <vt:lpwstr>0</vt:lpwstr>
  </property>
  <property fmtid="{D5CDD505-2E9C-101B-9397-08002B2CF9AE}" pid="9" name="MSIP_Label_695cf23d-70b0-4a80-9221-1d774ac27fb2_Tag">
    <vt:lpwstr>10, 3, 0, 1</vt:lpwstr>
  </property>
</Properties>
</file>